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8" r:id="rId2"/>
    <p:sldId id="279" r:id="rId3"/>
    <p:sldId id="274" r:id="rId4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7FC6472-1DAB-6852-1EB2-E83CDD043B26}" name="Brown, Farrah" initials="BF" userId="S::Farrah.Brown@cchmc.org::6c293eaa-87ca-4e87-88f5-0ec42119f89c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wasawa, Eri" initials="IE" lastIdx="4" clrIdx="0">
    <p:extLst>
      <p:ext uri="{19B8F6BF-5375-455C-9EA6-DF929625EA0E}">
        <p15:presenceInfo xmlns:p15="http://schemas.microsoft.com/office/powerpoint/2012/main" userId="S-1-5-21-2113169553-152591045-318601546-34640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365D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96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15" autoAdjust="0"/>
    <p:restoredTop sz="94660"/>
  </p:normalViewPr>
  <p:slideViewPr>
    <p:cSldViewPr snapToGrid="0">
      <p:cViewPr varScale="1">
        <p:scale>
          <a:sx n="72" d="100"/>
          <a:sy n="72" d="100"/>
        </p:scale>
        <p:origin x="99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8/10/relationships/authors" Target="authors.xml"/><Relationship Id="rId5" Type="http://schemas.openxmlformats.org/officeDocument/2006/relationships/commentAuthors" Target="commentAuthors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kamura, June Goto" userId="7ec9a00e-3046-427f-9b8d-a24ddb439277" providerId="ADAL" clId="{0F358CDD-071D-4051-934F-5621DD0767A4}"/>
    <pc:docChg chg="delSld">
      <pc:chgData name="Nakamura, June Goto" userId="7ec9a00e-3046-427f-9b8d-a24ddb439277" providerId="ADAL" clId="{0F358CDD-071D-4051-934F-5621DD0767A4}" dt="2023-04-05T16:12:45.829" v="0" actId="2696"/>
      <pc:docMkLst>
        <pc:docMk/>
      </pc:docMkLst>
      <pc:sldChg chg="del">
        <pc:chgData name="Nakamura, June Goto" userId="7ec9a00e-3046-427f-9b8d-a24ddb439277" providerId="ADAL" clId="{0F358CDD-071D-4051-934F-5621DD0767A4}" dt="2023-04-05T16:12:45.829" v="0" actId="2696"/>
        <pc:sldMkLst>
          <pc:docMk/>
          <pc:sldMk cId="2570402988" sldId="258"/>
        </pc:sldMkLst>
      </pc:sldChg>
      <pc:sldChg chg="del">
        <pc:chgData name="Nakamura, June Goto" userId="7ec9a00e-3046-427f-9b8d-a24ddb439277" providerId="ADAL" clId="{0F358CDD-071D-4051-934F-5621DD0767A4}" dt="2023-04-05T16:12:45.829" v="0" actId="2696"/>
        <pc:sldMkLst>
          <pc:docMk/>
          <pc:sldMk cId="3935660895" sldId="260"/>
        </pc:sldMkLst>
      </pc:sldChg>
      <pc:sldChg chg="del">
        <pc:chgData name="Nakamura, June Goto" userId="7ec9a00e-3046-427f-9b8d-a24ddb439277" providerId="ADAL" clId="{0F358CDD-071D-4051-934F-5621DD0767A4}" dt="2023-04-05T16:12:45.829" v="0" actId="2696"/>
        <pc:sldMkLst>
          <pc:docMk/>
          <pc:sldMk cId="1740201246" sldId="262"/>
        </pc:sldMkLst>
      </pc:sldChg>
      <pc:sldChg chg="del">
        <pc:chgData name="Nakamura, June Goto" userId="7ec9a00e-3046-427f-9b8d-a24ddb439277" providerId="ADAL" clId="{0F358CDD-071D-4051-934F-5621DD0767A4}" dt="2023-04-05T16:12:45.829" v="0" actId="2696"/>
        <pc:sldMkLst>
          <pc:docMk/>
          <pc:sldMk cId="794688065" sldId="265"/>
        </pc:sldMkLst>
      </pc:sldChg>
      <pc:sldChg chg="del">
        <pc:chgData name="Nakamura, June Goto" userId="7ec9a00e-3046-427f-9b8d-a24ddb439277" providerId="ADAL" clId="{0F358CDD-071D-4051-934F-5621DD0767A4}" dt="2023-04-05T16:12:45.829" v="0" actId="2696"/>
        <pc:sldMkLst>
          <pc:docMk/>
          <pc:sldMk cId="2415125025" sldId="267"/>
        </pc:sldMkLst>
      </pc:sldChg>
      <pc:sldChg chg="del">
        <pc:chgData name="Nakamura, June Goto" userId="7ec9a00e-3046-427f-9b8d-a24ddb439277" providerId="ADAL" clId="{0F358CDD-071D-4051-934F-5621DD0767A4}" dt="2023-04-05T16:12:45.829" v="0" actId="2696"/>
        <pc:sldMkLst>
          <pc:docMk/>
          <pc:sldMk cId="1294035448" sldId="269"/>
        </pc:sldMkLst>
      </pc:sldChg>
      <pc:sldChg chg="del">
        <pc:chgData name="Nakamura, June Goto" userId="7ec9a00e-3046-427f-9b8d-a24ddb439277" providerId="ADAL" clId="{0F358CDD-071D-4051-934F-5621DD0767A4}" dt="2023-04-05T16:12:45.829" v="0" actId="2696"/>
        <pc:sldMkLst>
          <pc:docMk/>
          <pc:sldMk cId="3588291317" sldId="273"/>
        </pc:sldMkLst>
      </pc:sldChg>
      <pc:sldChg chg="del">
        <pc:chgData name="Nakamura, June Goto" userId="7ec9a00e-3046-427f-9b8d-a24ddb439277" providerId="ADAL" clId="{0F358CDD-071D-4051-934F-5621DD0767A4}" dt="2023-04-05T16:12:45.829" v="0" actId="2696"/>
        <pc:sldMkLst>
          <pc:docMk/>
          <pc:sldMk cId="1050136679" sldId="276"/>
        </pc:sldMkLst>
      </pc:sldChg>
      <pc:sldChg chg="del">
        <pc:chgData name="Nakamura, June Goto" userId="7ec9a00e-3046-427f-9b8d-a24ddb439277" providerId="ADAL" clId="{0F358CDD-071D-4051-934F-5621DD0767A4}" dt="2023-04-05T16:12:45.829" v="0" actId="2696"/>
        <pc:sldMkLst>
          <pc:docMk/>
          <pc:sldMk cId="91457328" sldId="277"/>
        </pc:sldMkLst>
      </pc:sldChg>
      <pc:sldChg chg="del">
        <pc:chgData name="Nakamura, June Goto" userId="7ec9a00e-3046-427f-9b8d-a24ddb439277" providerId="ADAL" clId="{0F358CDD-071D-4051-934F-5621DD0767A4}" dt="2023-04-05T16:12:45.829" v="0" actId="2696"/>
        <pc:sldMkLst>
          <pc:docMk/>
          <pc:sldMk cId="3873045255" sldId="280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2FD5D-01E9-4A0D-ABBC-90B6300C3C31}" type="datetimeFigureOut">
              <a:rPr kumimoji="1" lang="ja-JP" altLang="en-US" smtClean="0"/>
              <a:t>2023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EFAE9-A4C0-4FAF-86DA-2729906605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9809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2FD5D-01E9-4A0D-ABBC-90B6300C3C31}" type="datetimeFigureOut">
              <a:rPr kumimoji="1" lang="ja-JP" altLang="en-US" smtClean="0"/>
              <a:t>2023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EFAE9-A4C0-4FAF-86DA-2729906605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0773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2FD5D-01E9-4A0D-ABBC-90B6300C3C31}" type="datetimeFigureOut">
              <a:rPr kumimoji="1" lang="ja-JP" altLang="en-US" smtClean="0"/>
              <a:t>2023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EFAE9-A4C0-4FAF-86DA-2729906605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1033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2FD5D-01E9-4A0D-ABBC-90B6300C3C31}" type="datetimeFigureOut">
              <a:rPr kumimoji="1" lang="ja-JP" altLang="en-US" smtClean="0"/>
              <a:t>2023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EFAE9-A4C0-4FAF-86DA-2729906605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3786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2FD5D-01E9-4A0D-ABBC-90B6300C3C31}" type="datetimeFigureOut">
              <a:rPr kumimoji="1" lang="ja-JP" altLang="en-US" smtClean="0"/>
              <a:t>2023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EFAE9-A4C0-4FAF-86DA-2729906605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6416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2FD5D-01E9-4A0D-ABBC-90B6300C3C31}" type="datetimeFigureOut">
              <a:rPr kumimoji="1" lang="ja-JP" altLang="en-US" smtClean="0"/>
              <a:t>2023/4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EFAE9-A4C0-4FAF-86DA-2729906605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9179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2FD5D-01E9-4A0D-ABBC-90B6300C3C31}" type="datetimeFigureOut">
              <a:rPr kumimoji="1" lang="ja-JP" altLang="en-US" smtClean="0"/>
              <a:t>2023/4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EFAE9-A4C0-4FAF-86DA-2729906605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6350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2FD5D-01E9-4A0D-ABBC-90B6300C3C31}" type="datetimeFigureOut">
              <a:rPr kumimoji="1" lang="ja-JP" altLang="en-US" smtClean="0"/>
              <a:t>2023/4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EFAE9-A4C0-4FAF-86DA-2729906605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1126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2FD5D-01E9-4A0D-ABBC-90B6300C3C31}" type="datetimeFigureOut">
              <a:rPr kumimoji="1" lang="ja-JP" altLang="en-US" smtClean="0"/>
              <a:t>2023/4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EFAE9-A4C0-4FAF-86DA-2729906605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4767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2FD5D-01E9-4A0D-ABBC-90B6300C3C31}" type="datetimeFigureOut">
              <a:rPr kumimoji="1" lang="ja-JP" altLang="en-US" smtClean="0"/>
              <a:t>2023/4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EFAE9-A4C0-4FAF-86DA-2729906605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071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2FD5D-01E9-4A0D-ABBC-90B6300C3C31}" type="datetimeFigureOut">
              <a:rPr kumimoji="1" lang="ja-JP" altLang="en-US" smtClean="0"/>
              <a:t>2023/4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EFAE9-A4C0-4FAF-86DA-2729906605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9266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D2FD5D-01E9-4A0D-ABBC-90B6300C3C31}" type="datetimeFigureOut">
              <a:rPr kumimoji="1" lang="ja-JP" altLang="en-US" smtClean="0"/>
              <a:t>2023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EFAE9-A4C0-4FAF-86DA-2729906605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6696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3" Type="http://schemas.openxmlformats.org/officeDocument/2006/relationships/image" Target="../media/image1.emf"/><Relationship Id="rId7" Type="http://schemas.openxmlformats.org/officeDocument/2006/relationships/oleObject" Target="../embeddings/oleObject3.bin"/><Relationship Id="rId12" Type="http://schemas.openxmlformats.org/officeDocument/2006/relationships/image" Target="../media/image6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oleObject" Target="../embeddings/oleObject5.bin"/><Relationship Id="rId5" Type="http://schemas.openxmlformats.org/officeDocument/2006/relationships/image" Target="../media/image2.emf"/><Relationship Id="rId10" Type="http://schemas.openxmlformats.org/officeDocument/2006/relationships/image" Target="../media/image5.emf"/><Relationship Id="rId4" Type="http://schemas.openxmlformats.org/officeDocument/2006/relationships/oleObject" Target="../embeddings/oleObject2.bin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image" Target="../media/image7.emf"/><Relationship Id="rId7" Type="http://schemas.openxmlformats.org/officeDocument/2006/relationships/image" Target="../media/image9.emf"/><Relationship Id="rId12" Type="http://schemas.openxmlformats.org/officeDocument/2006/relationships/image" Target="../media/image11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8.bin"/><Relationship Id="rId11" Type="http://schemas.openxmlformats.org/officeDocument/2006/relationships/oleObject" Target="../embeddings/oleObject10.bin"/><Relationship Id="rId5" Type="http://schemas.openxmlformats.org/officeDocument/2006/relationships/image" Target="../media/image8.emf"/><Relationship Id="rId10" Type="http://schemas.openxmlformats.org/officeDocument/2006/relationships/image" Target="../media/image10.emf"/><Relationship Id="rId4" Type="http://schemas.openxmlformats.org/officeDocument/2006/relationships/oleObject" Target="../embeddings/oleObject7.bin"/><Relationship Id="rId9" Type="http://schemas.openxmlformats.org/officeDocument/2006/relationships/oleObject" Target="../embeddings/oleObject9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image" Target="../media/image12.emf"/><Relationship Id="rId7" Type="http://schemas.openxmlformats.org/officeDocument/2006/relationships/oleObject" Target="../embeddings/oleObject13.bin"/><Relationship Id="rId2" Type="http://schemas.openxmlformats.org/officeDocument/2006/relationships/oleObject" Target="../embeddings/oleObject11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emf"/><Relationship Id="rId5" Type="http://schemas.openxmlformats.org/officeDocument/2006/relationships/oleObject" Target="../embeddings/oleObject12.bin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20">
            <a:extLst>
              <a:ext uri="{FF2B5EF4-FFF2-40B4-BE49-F238E27FC236}">
                <a16:creationId xmlns:a16="http://schemas.microsoft.com/office/drawing/2014/main" id="{F6FAAA10-9902-41C7-9E3A-EB7FEAA0E191}"/>
              </a:ext>
            </a:extLst>
          </p:cNvPr>
          <p:cNvSpPr txBox="1"/>
          <p:nvPr/>
        </p:nvSpPr>
        <p:spPr>
          <a:xfrm>
            <a:off x="-74491" y="4727"/>
            <a:ext cx="2862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4951194"/>
              </p:ext>
            </p:extLst>
          </p:nvPr>
        </p:nvGraphicFramePr>
        <p:xfrm>
          <a:off x="124669" y="3322453"/>
          <a:ext cx="2147693" cy="22968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361867" imgH="3598299" progId="Prism9.Document">
                  <p:embed/>
                </p:oleObj>
              </mc:Choice>
              <mc:Fallback>
                <p:oleObj name="Prism 9" r:id="rId2" imgW="3361867" imgH="3598299" progId="Prism9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24669" y="3322453"/>
                        <a:ext cx="2147693" cy="22968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7774969"/>
              </p:ext>
            </p:extLst>
          </p:nvPr>
        </p:nvGraphicFramePr>
        <p:xfrm>
          <a:off x="4217122" y="3403170"/>
          <a:ext cx="2004384" cy="22069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087443" imgH="3468644" progId="Prism9.Document">
                  <p:embed/>
                </p:oleObj>
              </mc:Choice>
              <mc:Fallback>
                <p:oleObj name="Prism 9" r:id="rId4" imgW="3087443" imgH="3468644" progId="Prism9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217122" y="3403170"/>
                        <a:ext cx="2004384" cy="22069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814148" y="3417286"/>
            <a:ext cx="740161" cy="611437"/>
          </a:xfrm>
          <a:prstGeom prst="rect">
            <a:avLst/>
          </a:prstGeom>
        </p:spPr>
      </p:pic>
      <p:sp>
        <p:nvSpPr>
          <p:cNvPr id="8" name="テキスト ボックス 13">
            <a:extLst>
              <a:ext uri="{FF2B5EF4-FFF2-40B4-BE49-F238E27FC236}">
                <a16:creationId xmlns:a16="http://schemas.microsoft.com/office/drawing/2014/main" id="{C3ABD96C-7149-4CEB-8B1C-67E3B9C315E9}"/>
              </a:ext>
            </a:extLst>
          </p:cNvPr>
          <p:cNvSpPr txBox="1"/>
          <p:nvPr/>
        </p:nvSpPr>
        <p:spPr>
          <a:xfrm>
            <a:off x="2044842" y="2921072"/>
            <a:ext cx="416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13">
            <a:extLst>
              <a:ext uri="{FF2B5EF4-FFF2-40B4-BE49-F238E27FC236}">
                <a16:creationId xmlns:a16="http://schemas.microsoft.com/office/drawing/2014/main" id="{C3ABD96C-7149-4CEB-8B1C-67E3B9C315E9}"/>
              </a:ext>
            </a:extLst>
          </p:cNvPr>
          <p:cNvSpPr txBox="1"/>
          <p:nvPr/>
        </p:nvSpPr>
        <p:spPr>
          <a:xfrm>
            <a:off x="4094333" y="2926149"/>
            <a:ext cx="416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20">
            <a:extLst>
              <a:ext uri="{FF2B5EF4-FFF2-40B4-BE49-F238E27FC236}">
                <a16:creationId xmlns:a16="http://schemas.microsoft.com/office/drawing/2014/main" id="{F6FAAA10-9902-41C7-9E3A-EB7FEAA0E191}"/>
              </a:ext>
            </a:extLst>
          </p:cNvPr>
          <p:cNvSpPr txBox="1"/>
          <p:nvPr/>
        </p:nvSpPr>
        <p:spPr>
          <a:xfrm>
            <a:off x="0" y="2599972"/>
            <a:ext cx="2862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3">
            <a:extLst>
              <a:ext uri="{FF2B5EF4-FFF2-40B4-BE49-F238E27FC236}">
                <a16:creationId xmlns:a16="http://schemas.microsoft.com/office/drawing/2014/main" id="{C3ABD96C-7149-4CEB-8B1C-67E3B9C315E9}"/>
              </a:ext>
            </a:extLst>
          </p:cNvPr>
          <p:cNvSpPr txBox="1"/>
          <p:nvPr/>
        </p:nvSpPr>
        <p:spPr>
          <a:xfrm>
            <a:off x="222593" y="420120"/>
            <a:ext cx="416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20">
            <a:extLst>
              <a:ext uri="{FF2B5EF4-FFF2-40B4-BE49-F238E27FC236}">
                <a16:creationId xmlns:a16="http://schemas.microsoft.com/office/drawing/2014/main" id="{F6FAAA10-9902-41C7-9E3A-EB7FEAA0E191}"/>
              </a:ext>
            </a:extLst>
          </p:cNvPr>
          <p:cNvSpPr txBox="1"/>
          <p:nvPr/>
        </p:nvSpPr>
        <p:spPr>
          <a:xfrm>
            <a:off x="-11515" y="5515223"/>
            <a:ext cx="2862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14716371"/>
              </p:ext>
            </p:extLst>
          </p:nvPr>
        </p:nvGraphicFramePr>
        <p:xfrm>
          <a:off x="204929" y="5972485"/>
          <a:ext cx="1865715" cy="23133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3004972" imgH="4052453" progId="Prism9.Document">
                  <p:embed/>
                </p:oleObj>
              </mc:Choice>
              <mc:Fallback>
                <p:oleObj name="Prism 9" r:id="rId7" imgW="3004972" imgH="4052453" progId="Prism9.Document">
                  <p:embed/>
                  <p:pic>
                    <p:nvPicPr>
                      <p:cNvPr id="14" name="Object 1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04929" y="5972485"/>
                        <a:ext cx="1865715" cy="23133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テキスト ボックス 13">
            <a:extLst>
              <a:ext uri="{FF2B5EF4-FFF2-40B4-BE49-F238E27FC236}">
                <a16:creationId xmlns:a16="http://schemas.microsoft.com/office/drawing/2014/main" id="{C3ABD96C-7149-4CEB-8B1C-67E3B9C315E9}"/>
              </a:ext>
            </a:extLst>
          </p:cNvPr>
          <p:cNvSpPr txBox="1"/>
          <p:nvPr/>
        </p:nvSpPr>
        <p:spPr>
          <a:xfrm>
            <a:off x="222593" y="6017808"/>
            <a:ext cx="416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01923" y="602515"/>
            <a:ext cx="841321" cy="695004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58725" y="6346010"/>
            <a:ext cx="841321" cy="695004"/>
          </a:xfrm>
          <a:prstGeom prst="rect">
            <a:avLst/>
          </a:prstGeom>
        </p:spPr>
      </p:pic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7692788"/>
              </p:ext>
            </p:extLst>
          </p:nvPr>
        </p:nvGraphicFramePr>
        <p:xfrm>
          <a:off x="63062" y="414564"/>
          <a:ext cx="1662113" cy="1993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3247344" imgH="4098193" progId="Prism9.Document">
                  <p:embed/>
                </p:oleObj>
              </mc:Choice>
              <mc:Fallback>
                <p:oleObj name="Prism 9" r:id="rId9" imgW="3247344" imgH="4098193" progId="Prism9.Document">
                  <p:embed/>
                  <p:pic>
                    <p:nvPicPr>
                      <p:cNvPr id="18" name="Object 17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3062" y="414564"/>
                        <a:ext cx="1662113" cy="1993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7013815"/>
              </p:ext>
            </p:extLst>
          </p:nvPr>
        </p:nvGraphicFramePr>
        <p:xfrm>
          <a:off x="2153713" y="3272941"/>
          <a:ext cx="2022475" cy="2162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1" imgW="3087443" imgH="3656284" progId="Prism9.Document">
                  <p:embed/>
                </p:oleObj>
              </mc:Choice>
              <mc:Fallback>
                <p:oleObj name="Prism 9" r:id="rId11" imgW="3087443" imgH="3656284" progId="Prism9.Document">
                  <p:embed/>
                  <p:pic>
                    <p:nvPicPr>
                      <p:cNvPr id="19" name="Object 18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153713" y="3272941"/>
                        <a:ext cx="2022475" cy="2162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テキスト ボックス 13">
            <a:extLst>
              <a:ext uri="{FF2B5EF4-FFF2-40B4-BE49-F238E27FC236}">
                <a16:creationId xmlns:a16="http://schemas.microsoft.com/office/drawing/2014/main" id="{C3ABD96C-7149-4CEB-8B1C-67E3B9C315E9}"/>
              </a:ext>
            </a:extLst>
          </p:cNvPr>
          <p:cNvSpPr txBox="1"/>
          <p:nvPr/>
        </p:nvSpPr>
        <p:spPr>
          <a:xfrm>
            <a:off x="222593" y="2921072"/>
            <a:ext cx="416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6C1F074-C215-4051-1B77-9C2530C52984}"/>
              </a:ext>
            </a:extLst>
          </p:cNvPr>
          <p:cNvSpPr txBox="1"/>
          <p:nvPr/>
        </p:nvSpPr>
        <p:spPr>
          <a:xfrm>
            <a:off x="424182" y="3132907"/>
            <a:ext cx="1851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8 Grey Matter Density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0C0FD7D-ACD2-F335-BF7A-E80ABED35047}"/>
              </a:ext>
            </a:extLst>
          </p:cNvPr>
          <p:cNvSpPr txBox="1"/>
          <p:nvPr/>
        </p:nvSpPr>
        <p:spPr>
          <a:xfrm>
            <a:off x="4585638" y="3132907"/>
            <a:ext cx="16620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8 Grey Matter %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BFB72F7-BB0B-2C9F-E6FB-AB96291A5F98}"/>
              </a:ext>
            </a:extLst>
          </p:cNvPr>
          <p:cNvSpPr txBox="1"/>
          <p:nvPr/>
        </p:nvSpPr>
        <p:spPr>
          <a:xfrm>
            <a:off x="2597971" y="3132907"/>
            <a:ext cx="16620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8 White Matter %</a:t>
            </a:r>
          </a:p>
        </p:txBody>
      </p:sp>
    </p:spTree>
    <p:extLst>
      <p:ext uri="{BB962C8B-B14F-4D97-AF65-F5344CB8AC3E}">
        <p14:creationId xmlns:p14="http://schemas.microsoft.com/office/powerpoint/2010/main" val="8844201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20">
            <a:extLst>
              <a:ext uri="{FF2B5EF4-FFF2-40B4-BE49-F238E27FC236}">
                <a16:creationId xmlns:a16="http://schemas.microsoft.com/office/drawing/2014/main" id="{F6FAAA10-9902-41C7-9E3A-EB7FEAA0E191}"/>
              </a:ext>
            </a:extLst>
          </p:cNvPr>
          <p:cNvSpPr txBox="1"/>
          <p:nvPr/>
        </p:nvSpPr>
        <p:spPr>
          <a:xfrm>
            <a:off x="29258" y="35827"/>
            <a:ext cx="2862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1624006"/>
              </p:ext>
            </p:extLst>
          </p:nvPr>
        </p:nvGraphicFramePr>
        <p:xfrm>
          <a:off x="122971" y="465796"/>
          <a:ext cx="1965428" cy="20228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986605" imgH="3073555" progId="Prism9.Document">
                  <p:embed/>
                </p:oleObj>
              </mc:Choice>
              <mc:Fallback>
                <p:oleObj name="Prism 9" r:id="rId2" imgW="2986605" imgH="3073555" progId="Prism9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22971" y="465796"/>
                        <a:ext cx="1965428" cy="20228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4007713"/>
              </p:ext>
            </p:extLst>
          </p:nvPr>
        </p:nvGraphicFramePr>
        <p:xfrm>
          <a:off x="3824156" y="3252788"/>
          <a:ext cx="2125797" cy="2130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963917" imgH="2973072" progId="Prism9.Document">
                  <p:embed/>
                </p:oleObj>
              </mc:Choice>
              <mc:Fallback>
                <p:oleObj name="Prism 9" r:id="rId4" imgW="2963917" imgH="2973072" progId="Prism9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824156" y="3252788"/>
                        <a:ext cx="2125797" cy="2130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8252389"/>
              </p:ext>
            </p:extLst>
          </p:nvPr>
        </p:nvGraphicFramePr>
        <p:xfrm>
          <a:off x="-39688" y="3252788"/>
          <a:ext cx="2214563" cy="2130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155869" imgH="3037179" progId="Prism9.Document">
                  <p:embed/>
                </p:oleObj>
              </mc:Choice>
              <mc:Fallback>
                <p:oleObj name="Prism 9" r:id="rId6" imgW="3155869" imgH="3037179" progId="Prism9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-39688" y="3252788"/>
                        <a:ext cx="2214563" cy="2130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" name="Picture 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917381" y="3102273"/>
            <a:ext cx="841321" cy="695004"/>
          </a:xfrm>
          <a:prstGeom prst="rect">
            <a:avLst/>
          </a:prstGeom>
        </p:spPr>
      </p:pic>
      <p:sp>
        <p:nvSpPr>
          <p:cNvPr id="9" name="テキスト ボックス 13">
            <a:extLst>
              <a:ext uri="{FF2B5EF4-FFF2-40B4-BE49-F238E27FC236}">
                <a16:creationId xmlns:a16="http://schemas.microsoft.com/office/drawing/2014/main" id="{C3ABD96C-7149-4CEB-8B1C-67E3B9C315E9}"/>
              </a:ext>
            </a:extLst>
          </p:cNvPr>
          <p:cNvSpPr txBox="1"/>
          <p:nvPr/>
        </p:nvSpPr>
        <p:spPr>
          <a:xfrm>
            <a:off x="221192" y="365804"/>
            <a:ext cx="416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20">
            <a:extLst>
              <a:ext uri="{FF2B5EF4-FFF2-40B4-BE49-F238E27FC236}">
                <a16:creationId xmlns:a16="http://schemas.microsoft.com/office/drawing/2014/main" id="{F6FAAA10-9902-41C7-9E3A-EB7FEAA0E191}"/>
              </a:ext>
            </a:extLst>
          </p:cNvPr>
          <p:cNvSpPr txBox="1"/>
          <p:nvPr/>
        </p:nvSpPr>
        <p:spPr>
          <a:xfrm>
            <a:off x="29259" y="2556245"/>
            <a:ext cx="2862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3">
            <a:extLst>
              <a:ext uri="{FF2B5EF4-FFF2-40B4-BE49-F238E27FC236}">
                <a16:creationId xmlns:a16="http://schemas.microsoft.com/office/drawing/2014/main" id="{C3ABD96C-7149-4CEB-8B1C-67E3B9C315E9}"/>
              </a:ext>
            </a:extLst>
          </p:cNvPr>
          <p:cNvSpPr txBox="1"/>
          <p:nvPr/>
        </p:nvSpPr>
        <p:spPr>
          <a:xfrm>
            <a:off x="218889" y="6311781"/>
            <a:ext cx="416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3">
            <a:extLst>
              <a:ext uri="{FF2B5EF4-FFF2-40B4-BE49-F238E27FC236}">
                <a16:creationId xmlns:a16="http://schemas.microsoft.com/office/drawing/2014/main" id="{C3ABD96C-7149-4CEB-8B1C-67E3B9C315E9}"/>
              </a:ext>
            </a:extLst>
          </p:cNvPr>
          <p:cNvSpPr txBox="1"/>
          <p:nvPr/>
        </p:nvSpPr>
        <p:spPr>
          <a:xfrm>
            <a:off x="4110495" y="2981454"/>
            <a:ext cx="416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3494803"/>
              </p:ext>
            </p:extLst>
          </p:nvPr>
        </p:nvGraphicFramePr>
        <p:xfrm>
          <a:off x="288958" y="6369645"/>
          <a:ext cx="2145932" cy="2238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2931865" imgH="3055547" progId="Prism9.Document">
                  <p:embed/>
                </p:oleObj>
              </mc:Choice>
              <mc:Fallback>
                <p:oleObj name="Prism 9" r:id="rId9" imgW="2931865" imgH="3055547" progId="Prism9.Document">
                  <p:embed/>
                  <p:pic>
                    <p:nvPicPr>
                      <p:cNvPr id="13" name="Object 12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88958" y="6369645"/>
                        <a:ext cx="2145932" cy="2238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テキスト ボックス 20">
            <a:extLst>
              <a:ext uri="{FF2B5EF4-FFF2-40B4-BE49-F238E27FC236}">
                <a16:creationId xmlns:a16="http://schemas.microsoft.com/office/drawing/2014/main" id="{F6FAAA10-9902-41C7-9E3A-EB7FEAA0E191}"/>
              </a:ext>
            </a:extLst>
          </p:cNvPr>
          <p:cNvSpPr txBox="1"/>
          <p:nvPr/>
        </p:nvSpPr>
        <p:spPr>
          <a:xfrm>
            <a:off x="29258" y="5942449"/>
            <a:ext cx="2862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3">
            <a:extLst>
              <a:ext uri="{FF2B5EF4-FFF2-40B4-BE49-F238E27FC236}">
                <a16:creationId xmlns:a16="http://schemas.microsoft.com/office/drawing/2014/main" id="{C3ABD96C-7149-4CEB-8B1C-67E3B9C315E9}"/>
              </a:ext>
            </a:extLst>
          </p:cNvPr>
          <p:cNvSpPr txBox="1"/>
          <p:nvPr/>
        </p:nvSpPr>
        <p:spPr>
          <a:xfrm>
            <a:off x="2017270" y="2981454"/>
            <a:ext cx="416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28971" y="607763"/>
            <a:ext cx="841321" cy="695004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29441" y="6496447"/>
            <a:ext cx="841321" cy="695004"/>
          </a:xfrm>
          <a:prstGeom prst="rect">
            <a:avLst/>
          </a:prstGeom>
        </p:spPr>
      </p:pic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4874167"/>
              </p:ext>
            </p:extLst>
          </p:nvPr>
        </p:nvGraphicFramePr>
        <p:xfrm>
          <a:off x="2012950" y="3251200"/>
          <a:ext cx="2003425" cy="194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1" imgW="3000291" imgH="2910405" progId="Prism9.Document">
                  <p:embed/>
                </p:oleObj>
              </mc:Choice>
              <mc:Fallback>
                <p:oleObj name="Prism 9" r:id="rId11" imgW="3000291" imgH="2910405" progId="Prism9.Document">
                  <p:embed/>
                  <p:pic>
                    <p:nvPicPr>
                      <p:cNvPr id="18" name="Object 17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012950" y="3251200"/>
                        <a:ext cx="2003425" cy="1943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テキスト ボックス 13">
            <a:extLst>
              <a:ext uri="{FF2B5EF4-FFF2-40B4-BE49-F238E27FC236}">
                <a16:creationId xmlns:a16="http://schemas.microsoft.com/office/drawing/2014/main" id="{C3ABD96C-7149-4CEB-8B1C-67E3B9C315E9}"/>
              </a:ext>
            </a:extLst>
          </p:cNvPr>
          <p:cNvSpPr txBox="1"/>
          <p:nvPr/>
        </p:nvSpPr>
        <p:spPr>
          <a:xfrm>
            <a:off x="218889" y="2983441"/>
            <a:ext cx="416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0781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テキスト ボックス 13">
            <a:extLst>
              <a:ext uri="{FF2B5EF4-FFF2-40B4-BE49-F238E27FC236}">
                <a16:creationId xmlns:a16="http://schemas.microsoft.com/office/drawing/2014/main" id="{C3ABD96C-7149-4CEB-8B1C-67E3B9C315E9}"/>
              </a:ext>
            </a:extLst>
          </p:cNvPr>
          <p:cNvSpPr txBox="1"/>
          <p:nvPr/>
        </p:nvSpPr>
        <p:spPr>
          <a:xfrm>
            <a:off x="86687" y="607026"/>
            <a:ext cx="416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13">
            <a:extLst>
              <a:ext uri="{FF2B5EF4-FFF2-40B4-BE49-F238E27FC236}">
                <a16:creationId xmlns:a16="http://schemas.microsoft.com/office/drawing/2014/main" id="{C3ABD96C-7149-4CEB-8B1C-67E3B9C315E9}"/>
              </a:ext>
            </a:extLst>
          </p:cNvPr>
          <p:cNvSpPr txBox="1"/>
          <p:nvPr/>
        </p:nvSpPr>
        <p:spPr>
          <a:xfrm>
            <a:off x="101479" y="5982072"/>
            <a:ext cx="26598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8" name="Object 4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5639991"/>
              </p:ext>
            </p:extLst>
          </p:nvPr>
        </p:nvGraphicFramePr>
        <p:xfrm>
          <a:off x="157163" y="366713"/>
          <a:ext cx="1885950" cy="2579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822023" imgH="3861932" progId="Prism9.Document">
                  <p:embed/>
                </p:oleObj>
              </mc:Choice>
              <mc:Fallback>
                <p:oleObj name="Prism 9" r:id="rId2" imgW="2822023" imgH="3861932" progId="Prism9.Document">
                  <p:embed/>
                  <p:pic>
                    <p:nvPicPr>
                      <p:cNvPr id="48" name="Object 47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57163" y="366713"/>
                        <a:ext cx="1885950" cy="2579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3" name="テキスト ボックス 13">
            <a:extLst>
              <a:ext uri="{FF2B5EF4-FFF2-40B4-BE49-F238E27FC236}">
                <a16:creationId xmlns:a16="http://schemas.microsoft.com/office/drawing/2014/main" id="{C3ABD96C-7149-4CEB-8B1C-67E3B9C315E9}"/>
              </a:ext>
            </a:extLst>
          </p:cNvPr>
          <p:cNvSpPr txBox="1"/>
          <p:nvPr/>
        </p:nvSpPr>
        <p:spPr>
          <a:xfrm>
            <a:off x="157163" y="3415704"/>
            <a:ext cx="416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13">
            <a:extLst>
              <a:ext uri="{FF2B5EF4-FFF2-40B4-BE49-F238E27FC236}">
                <a16:creationId xmlns:a16="http://schemas.microsoft.com/office/drawing/2014/main" id="{C3ABD96C-7149-4CEB-8B1C-67E3B9C315E9}"/>
              </a:ext>
            </a:extLst>
          </p:cNvPr>
          <p:cNvSpPr txBox="1"/>
          <p:nvPr/>
        </p:nvSpPr>
        <p:spPr>
          <a:xfrm>
            <a:off x="2090219" y="3415704"/>
            <a:ext cx="416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20">
            <a:extLst>
              <a:ext uri="{FF2B5EF4-FFF2-40B4-BE49-F238E27FC236}">
                <a16:creationId xmlns:a16="http://schemas.microsoft.com/office/drawing/2014/main" id="{F6FAAA10-9902-41C7-9E3A-EB7FEAA0E191}"/>
              </a:ext>
            </a:extLst>
          </p:cNvPr>
          <p:cNvSpPr txBox="1"/>
          <p:nvPr/>
        </p:nvSpPr>
        <p:spPr>
          <a:xfrm>
            <a:off x="0" y="48781"/>
            <a:ext cx="2862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20">
            <a:extLst>
              <a:ext uri="{FF2B5EF4-FFF2-40B4-BE49-F238E27FC236}">
                <a16:creationId xmlns:a16="http://schemas.microsoft.com/office/drawing/2014/main" id="{F6FAAA10-9902-41C7-9E3A-EB7FEAA0E191}"/>
              </a:ext>
            </a:extLst>
          </p:cNvPr>
          <p:cNvSpPr txBox="1"/>
          <p:nvPr/>
        </p:nvSpPr>
        <p:spPr>
          <a:xfrm>
            <a:off x="86687" y="2970956"/>
            <a:ext cx="2862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00573" y="646817"/>
            <a:ext cx="841321" cy="695004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03382" y="3719557"/>
            <a:ext cx="841321" cy="695004"/>
          </a:xfrm>
          <a:prstGeom prst="rect">
            <a:avLst/>
          </a:prstGeom>
        </p:spPr>
      </p:pic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D384AED9-FD26-FF82-79A5-6C4DF7C4AB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8865185"/>
              </p:ext>
            </p:extLst>
          </p:nvPr>
        </p:nvGraphicFramePr>
        <p:xfrm>
          <a:off x="2068424" y="3457369"/>
          <a:ext cx="2280076" cy="2610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2901253" imgH="3322061" progId="Prism9.Document">
                  <p:embed/>
                </p:oleObj>
              </mc:Choice>
              <mc:Fallback>
                <p:oleObj name="Prism 9" r:id="rId5" imgW="2901253" imgH="3322061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D384AED9-FD26-FF82-79A5-6C4DF7C4AB8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068424" y="3457369"/>
                        <a:ext cx="2280076" cy="2610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5DC3412-94E4-F276-43E7-9D4D4F9E02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0351571"/>
              </p:ext>
            </p:extLst>
          </p:nvPr>
        </p:nvGraphicFramePr>
        <p:xfrm>
          <a:off x="56779" y="3499379"/>
          <a:ext cx="2188278" cy="25222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2901253" imgH="3345111" progId="Prism9.Document">
                  <p:embed/>
                </p:oleObj>
              </mc:Choice>
              <mc:Fallback>
                <p:oleObj name="Prism 9" r:id="rId7" imgW="2901253" imgH="3345111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A5DC3412-94E4-F276-43E7-9D4D4F9E02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6779" y="3499379"/>
                        <a:ext cx="2188278" cy="25222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A0D8B063-7E09-51C2-CC25-3697E9497E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5275630"/>
              </p:ext>
            </p:extLst>
          </p:nvPr>
        </p:nvGraphicFramePr>
        <p:xfrm>
          <a:off x="157163" y="6458376"/>
          <a:ext cx="6496043" cy="1760305"/>
        </p:xfrm>
        <a:graphic>
          <a:graphicData uri="http://schemas.openxmlformats.org/drawingml/2006/table">
            <a:tbl>
              <a:tblPr/>
              <a:tblGrid>
                <a:gridCol w="716955">
                  <a:extLst>
                    <a:ext uri="{9D8B030D-6E8A-4147-A177-3AD203B41FA5}">
                      <a16:colId xmlns:a16="http://schemas.microsoft.com/office/drawing/2014/main" val="2643415165"/>
                    </a:ext>
                  </a:extLst>
                </a:gridCol>
                <a:gridCol w="412792">
                  <a:extLst>
                    <a:ext uri="{9D8B030D-6E8A-4147-A177-3AD203B41FA5}">
                      <a16:colId xmlns:a16="http://schemas.microsoft.com/office/drawing/2014/main" val="2010365728"/>
                    </a:ext>
                  </a:extLst>
                </a:gridCol>
                <a:gridCol w="412792">
                  <a:extLst>
                    <a:ext uri="{9D8B030D-6E8A-4147-A177-3AD203B41FA5}">
                      <a16:colId xmlns:a16="http://schemas.microsoft.com/office/drawing/2014/main" val="733680432"/>
                    </a:ext>
                  </a:extLst>
                </a:gridCol>
                <a:gridCol w="412792">
                  <a:extLst>
                    <a:ext uri="{9D8B030D-6E8A-4147-A177-3AD203B41FA5}">
                      <a16:colId xmlns:a16="http://schemas.microsoft.com/office/drawing/2014/main" val="1640295743"/>
                    </a:ext>
                  </a:extLst>
                </a:gridCol>
                <a:gridCol w="412792">
                  <a:extLst>
                    <a:ext uri="{9D8B030D-6E8A-4147-A177-3AD203B41FA5}">
                      <a16:colId xmlns:a16="http://schemas.microsoft.com/office/drawing/2014/main" val="2505486860"/>
                    </a:ext>
                  </a:extLst>
                </a:gridCol>
                <a:gridCol w="412792">
                  <a:extLst>
                    <a:ext uri="{9D8B030D-6E8A-4147-A177-3AD203B41FA5}">
                      <a16:colId xmlns:a16="http://schemas.microsoft.com/office/drawing/2014/main" val="329582243"/>
                    </a:ext>
                  </a:extLst>
                </a:gridCol>
                <a:gridCol w="412792">
                  <a:extLst>
                    <a:ext uri="{9D8B030D-6E8A-4147-A177-3AD203B41FA5}">
                      <a16:colId xmlns:a16="http://schemas.microsoft.com/office/drawing/2014/main" val="310551929"/>
                    </a:ext>
                  </a:extLst>
                </a:gridCol>
                <a:gridCol w="412792">
                  <a:extLst>
                    <a:ext uri="{9D8B030D-6E8A-4147-A177-3AD203B41FA5}">
                      <a16:colId xmlns:a16="http://schemas.microsoft.com/office/drawing/2014/main" val="3548946936"/>
                    </a:ext>
                  </a:extLst>
                </a:gridCol>
                <a:gridCol w="412792">
                  <a:extLst>
                    <a:ext uri="{9D8B030D-6E8A-4147-A177-3AD203B41FA5}">
                      <a16:colId xmlns:a16="http://schemas.microsoft.com/office/drawing/2014/main" val="3700582487"/>
                    </a:ext>
                  </a:extLst>
                </a:gridCol>
                <a:gridCol w="412792">
                  <a:extLst>
                    <a:ext uri="{9D8B030D-6E8A-4147-A177-3AD203B41FA5}">
                      <a16:colId xmlns:a16="http://schemas.microsoft.com/office/drawing/2014/main" val="2917894058"/>
                    </a:ext>
                  </a:extLst>
                </a:gridCol>
                <a:gridCol w="412792">
                  <a:extLst>
                    <a:ext uri="{9D8B030D-6E8A-4147-A177-3AD203B41FA5}">
                      <a16:colId xmlns:a16="http://schemas.microsoft.com/office/drawing/2014/main" val="785212381"/>
                    </a:ext>
                  </a:extLst>
                </a:gridCol>
                <a:gridCol w="412792">
                  <a:extLst>
                    <a:ext uri="{9D8B030D-6E8A-4147-A177-3AD203B41FA5}">
                      <a16:colId xmlns:a16="http://schemas.microsoft.com/office/drawing/2014/main" val="978063260"/>
                    </a:ext>
                  </a:extLst>
                </a:gridCol>
                <a:gridCol w="412792">
                  <a:extLst>
                    <a:ext uri="{9D8B030D-6E8A-4147-A177-3AD203B41FA5}">
                      <a16:colId xmlns:a16="http://schemas.microsoft.com/office/drawing/2014/main" val="37522519"/>
                    </a:ext>
                  </a:extLst>
                </a:gridCol>
                <a:gridCol w="412792">
                  <a:extLst>
                    <a:ext uri="{9D8B030D-6E8A-4147-A177-3AD203B41FA5}">
                      <a16:colId xmlns:a16="http://schemas.microsoft.com/office/drawing/2014/main" val="8655652"/>
                    </a:ext>
                  </a:extLst>
                </a:gridCol>
                <a:gridCol w="412792">
                  <a:extLst>
                    <a:ext uri="{9D8B030D-6E8A-4147-A177-3AD203B41FA5}">
                      <a16:colId xmlns:a16="http://schemas.microsoft.com/office/drawing/2014/main" val="302668446"/>
                    </a:ext>
                  </a:extLst>
                </a:gridCol>
              </a:tblGrid>
              <a:tr h="22812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gures</a:t>
                      </a:r>
                    </a:p>
                  </a:txBody>
                  <a:tcPr marL="5432" marR="5432" marT="5432" marB="26071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B II-IV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B VI-V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B WM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D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B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C 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E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F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B GM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B WM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B TC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B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B top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B bottom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279949"/>
                  </a:ext>
                </a:extLst>
              </a:tr>
              <a:tr h="2337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otype p value              (WT vs prh)  </a:t>
                      </a:r>
                    </a:p>
                  </a:txBody>
                  <a:tcPr marL="5432" marR="5432" marT="5432" marB="26071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16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59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47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78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5802971"/>
                  </a:ext>
                </a:extLst>
              </a:tr>
              <a:tr h="2337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 p value (Untreated vs PLX)</a:t>
                      </a:r>
                    </a:p>
                  </a:txBody>
                  <a:tcPr marL="5432" marR="5432" marT="5432" marB="26071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258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2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193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94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37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0154854"/>
                  </a:ext>
                </a:extLst>
              </a:tr>
              <a:tr h="1326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actions</a:t>
                      </a:r>
                    </a:p>
                  </a:txBody>
                  <a:tcPr marL="5432" marR="5432" marT="5432" marB="26071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2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03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727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051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472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03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3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33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39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9852200"/>
                  </a:ext>
                </a:extLst>
              </a:tr>
              <a:tr h="132611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32" marR="5432" marT="5432" marB="26071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32" marR="5432" marT="5432" marB="26071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32" marR="5432" marT="5432" marB="26071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32" marR="5432" marT="5432" marB="26071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32" marR="5432" marT="5432" marB="26071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32" marR="5432" marT="5432" marB="26071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32" marR="5432" marT="5432" marB="26071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32" marR="5432" marT="5432" marB="26071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32" marR="5432" marT="5432" marB="26071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32" marR="5432" marT="5432" marB="26071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32" marR="5432" marT="5432" marB="26071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32" marR="5432" marT="5432" marB="26071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32" marR="5432" marT="5432" marB="26071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32" marR="5432" marT="5432" marB="26071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32" marR="5432" marT="5432" marB="26071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9489234"/>
                  </a:ext>
                </a:extLst>
              </a:tr>
              <a:tr h="1326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gures</a:t>
                      </a:r>
                    </a:p>
                  </a:txBody>
                  <a:tcPr marL="5432" marR="5432" marT="5432" marB="26071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D left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D right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E left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E right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B II-IV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B VI-V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B WM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D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E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B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C 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E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F 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B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6678111"/>
                  </a:ext>
                </a:extLst>
              </a:tr>
              <a:tr h="2337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otype p value              (WT vs prh)  </a:t>
                      </a:r>
                    </a:p>
                  </a:txBody>
                  <a:tcPr marL="5432" marR="5432" marT="5432" marB="26071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408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8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52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5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57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52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65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8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42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8049525"/>
                  </a:ext>
                </a:extLst>
              </a:tr>
              <a:tr h="2337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 p value (Untreated vs PLX)</a:t>
                      </a:r>
                    </a:p>
                  </a:txBody>
                  <a:tcPr marL="5432" marR="5432" marT="5432" marB="26071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248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18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283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212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6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356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9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23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78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88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**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0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905917"/>
                  </a:ext>
                </a:extLst>
              </a:tr>
              <a:tr h="1326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actions</a:t>
                      </a:r>
                    </a:p>
                  </a:txBody>
                  <a:tcPr marL="5432" marR="5432" marT="5432" marB="26071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972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93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04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19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24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279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6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17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5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17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94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88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9*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68*</a:t>
                      </a:r>
                    </a:p>
                  </a:txBody>
                  <a:tcPr marL="5432" marR="5432" marT="5432" marB="26071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75746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084911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  <a:ln w="12700" cap="flat">
          <a:solidFill>
            <a:srgbClr val="000000"/>
          </a:solidFill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ctr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100" b="1" i="0" u="none" strike="noStrike" cap="none" spc="0" normalizeH="0" baseline="0" dirty="0">
            <a:ln>
              <a:noFill/>
            </a:ln>
            <a:solidFill>
              <a:srgbClr val="000000"/>
            </a:solidFill>
            <a:effectLst/>
            <a:uFillTx/>
            <a:latin typeface="Arial"/>
            <a:ea typeface="Arial"/>
            <a:cs typeface="Arial"/>
            <a:sym typeface="Arial"/>
          </a:defRPr>
        </a:def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199</TotalTime>
  <Words>296</Words>
  <Application>Microsoft Office PowerPoint</Application>
  <PresentationFormat>Letter Paper (8.5x11 in)</PresentationFormat>
  <Paragraphs>145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テーマ</vt:lpstr>
      <vt:lpstr>Prism 9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wasawa, Eri</dc:creator>
  <cp:lastModifiedBy>Nakamura, June Goto</cp:lastModifiedBy>
  <cp:revision>523</cp:revision>
  <cp:lastPrinted>2023-04-02T20:36:24Z</cp:lastPrinted>
  <dcterms:created xsi:type="dcterms:W3CDTF">2020-03-25T11:00:55Z</dcterms:created>
  <dcterms:modified xsi:type="dcterms:W3CDTF">2023-04-05T16:12:50Z</dcterms:modified>
</cp:coreProperties>
</file>